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5" r:id="rId4"/>
    <p:sldId id="268" r:id="rId5"/>
    <p:sldId id="267" r:id="rId6"/>
    <p:sldId id="266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65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E56029-B069-530F-ED02-C1EEBD852F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F59350-1826-E10B-32AE-5F7FE45558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AFE3D9-687F-B8CD-8806-57E674D56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526E2D-DF54-8132-707F-A2F8691C0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ADABF4-0079-FABA-FF1B-868E94BCC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680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2BB039-0D7F-AE37-A8ED-E67F983217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B3C6E7-1DEA-FC7B-C89B-FD71C8DEC5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84A224-1259-BCE6-E52F-482CC672C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E4D835-CDC6-7BFD-0F38-2106091339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D7506B-4F39-352C-2145-4A1352123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55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0541AC-E7E8-5907-7474-A2ECF12A93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5CD902-1359-BBC3-6CD2-CA3707372C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683300-1BC2-588B-5CD1-666FCE76B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63C220-925A-5C55-887C-78A66BE06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68F27C-9868-0AA2-445B-FFCC4097A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622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2B945F-9804-3442-4323-5578C43359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0BB9D6-D36F-5C01-1A0F-A2D0F39348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8C32B-835E-3F77-2154-977F0A3F8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626B9C-445B-5125-9840-C99AC40964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DC7BC1-BBB3-01F7-005B-FB48E8E0B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51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346A54-09C0-CC85-1828-FE735A48C7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8BAA33-21AF-1CBF-DEEF-31ECAC60D1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C3E618-9764-C06A-0AE1-2DAFB445AC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B0566D-C26E-A5D6-8778-4C4E8CD9B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9E0F71-E416-99CD-342B-4A04A10E0B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016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98D1D6-C7E9-8AE2-E555-075F33070C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105711-8F8A-2FBC-BE98-FD16E97F15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D7ADEB-1F14-F780-3186-628ED87B6A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103C8D-AFF4-AA6A-EFFC-031CA83F1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49D758-E649-5275-589A-7645562F85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6ECB6B-6AF0-E594-2CA5-AF71716AA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589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FE14B5-EF81-829B-3F71-6BAAD461CC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8D734F-6562-A129-C874-D47B4562D2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8284FF-4EF5-D3A0-31C7-EA1A86BC9C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A285C8-B7FC-7E58-4F73-BDF9BF11BE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D7DE55-FB77-47EC-DE49-DDEAD1C080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A140C9-E832-B87D-620F-B611D4BDB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3173EF-1026-06BD-2DE3-37006A7CC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BA5863-6DC7-C016-BB19-78450D826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991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780620-F2AF-F518-0A64-237E69B626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DC974E-A9CF-AA06-B603-864579885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FE9F7F0-89A9-C492-AF9E-D51DD2FDA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C142DA-D8AE-BE4A-4E6A-D7E8E739E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655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DED567-5E32-5357-72B3-EF6CC4E6C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80CAEE-2DE0-6320-463F-48BCE5253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924D0F-45EE-9A99-987E-A17247B1FD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170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DF0DB9-5AB2-233D-9C70-3B4D751C69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BFB6C1-0FB3-4D36-957F-D1DD33F048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6A1904-EB85-E11E-A0EB-AE72412FB8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72170B-A0A5-69E5-470B-835F263C7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192EF8-C34C-0C47-6604-2F6ADE562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8AEA0D-208C-B967-3E29-4813E6473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006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1ED059-B8A1-FA98-F463-B897F4AF6A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F3E15C-F1E8-BAB4-E3DE-6ED9F40CC5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4A20DA-D305-36A4-A505-BF91C26A5C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A9D364-3558-5B69-782A-6BA7A854C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668E50-A794-6D78-8B81-CF7D0A0DF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7C3C11-842B-75C1-28E9-76E6D83B0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689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96B14E-B742-91A2-AC7E-53772E55EC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1D26F-A5AF-1AA5-5178-917EFCF9CE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62AFE5-1699-F6DF-B3EB-300B631ED1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3759D-9CC9-4184-8A60-E51ADADEE45D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C4B10D-C684-651D-44D9-BE06C3B11B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EA79B3-980C-B3D6-E59A-05C43763BC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FCDEA-0518-4387-86CB-D6479ED933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289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www.cbioportal.org/" TargetMode="Externa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://www.cbioportal.org/" TargetMode="External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D5BFFF2-41A0-E816-4045-82594BA2F63B}"/>
              </a:ext>
            </a:extLst>
          </p:cNvPr>
          <p:cNvSpPr txBox="1"/>
          <p:nvPr/>
        </p:nvSpPr>
        <p:spPr>
          <a:xfrm>
            <a:off x="425513" y="244443"/>
            <a:ext cx="1118103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#1. Genomic alterations along the PI3K/AKT/mTOR pathwa</a:t>
            </a:r>
            <a:r>
              <a:rPr lang="en-US" dirty="0"/>
              <a:t>y</a:t>
            </a: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 analyzed The Cancer Genome Atlas (TCGA) database including 511 lung squamous cell carcinoma samples to assess the prevalence of alterations at 17 genes along the PI3K/AKT/mTOR pathway. Alterations in this pathway were present in 88.8% of cases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and 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most frequently altered genes we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K3C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E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CTO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hich accounted for 50.09% (256 samples), 17.02% (87 samples), and 12.7% (65 samples) of cases, respectively. Similar to lung adenocarcinomas, most genetic alterations in lung squamous cell carcinomas were putative drivers. For example, all 256 cases (100%) with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K3C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terations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classified as putative drivers, consisting of 59 activating mutations, 176 gene amplifications, and 21 cases with combined activating mutations and gene amplifications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E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terations (17.02%) included 36 deep deletions and 48 mutations that were known or likely oncogenic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5283650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586698B-ADF5-B84B-E07F-07E42B2877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4395" y="1436848"/>
            <a:ext cx="4694786" cy="375065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999BAC00-37A3-2254-4225-B3F053F59587}"/>
              </a:ext>
            </a:extLst>
          </p:cNvPr>
          <p:cNvSpPr/>
          <p:nvPr/>
        </p:nvSpPr>
        <p:spPr>
          <a:xfrm>
            <a:off x="4023999" y="151256"/>
            <a:ext cx="3776662" cy="914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ng Squamous Cell Carcinom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19F1A53-B474-2231-3E57-B57070C1BA1F}"/>
              </a:ext>
            </a:extLst>
          </p:cNvPr>
          <p:cNvSpPr txBox="1"/>
          <p:nvPr/>
        </p:nvSpPr>
        <p:spPr>
          <a:xfrm>
            <a:off x="235390" y="181069"/>
            <a:ext cx="9325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5EF519-85D8-9041-6CAB-50C58BECE50A}"/>
              </a:ext>
            </a:extLst>
          </p:cNvPr>
          <p:cNvSpPr txBox="1"/>
          <p:nvPr/>
        </p:nvSpPr>
        <p:spPr>
          <a:xfrm>
            <a:off x="692670" y="5074396"/>
            <a:ext cx="1114373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erations along the PI3K/AKT/mTOR pathway in lung squamous cell carcinoma were analyzed using genomic data from the TCGA database through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BioPort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www.cbioportal.or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Genomic alterations in 17 genes within the PI3K pathway, along with their combined alterations, are shown.</a:t>
            </a:r>
            <a:endParaRPr lang="en-US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4326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1795574-DB14-3BE9-80DE-B5298EE31D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5914529"/>
              </p:ext>
            </p:extLst>
          </p:nvPr>
        </p:nvGraphicFramePr>
        <p:xfrm>
          <a:off x="334978" y="601660"/>
          <a:ext cx="11564919" cy="56546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6922">
                  <a:extLst>
                    <a:ext uri="{9D8B030D-6E8A-4147-A177-3AD203B41FA5}">
                      <a16:colId xmlns:a16="http://schemas.microsoft.com/office/drawing/2014/main" val="1075572924"/>
                    </a:ext>
                  </a:extLst>
                </a:gridCol>
                <a:gridCol w="624060">
                  <a:extLst>
                    <a:ext uri="{9D8B030D-6E8A-4147-A177-3AD203B41FA5}">
                      <a16:colId xmlns:a16="http://schemas.microsoft.com/office/drawing/2014/main" val="1503756892"/>
                    </a:ext>
                  </a:extLst>
                </a:gridCol>
                <a:gridCol w="571105">
                  <a:extLst>
                    <a:ext uri="{9D8B030D-6E8A-4147-A177-3AD203B41FA5}">
                      <a16:colId xmlns:a16="http://schemas.microsoft.com/office/drawing/2014/main" val="3892668475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2404073605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1950272782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4201470496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3236878767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1768975523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518210917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4163397307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3118658965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2736977067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3520646166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2806122359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1576656589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3480364611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2035875299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1541524981"/>
                    </a:ext>
                  </a:extLst>
                </a:gridCol>
                <a:gridCol w="592052">
                  <a:extLst>
                    <a:ext uri="{9D8B030D-6E8A-4147-A177-3AD203B41FA5}">
                      <a16:colId xmlns:a16="http://schemas.microsoft.com/office/drawing/2014/main" val="2371278026"/>
                    </a:ext>
                  </a:extLst>
                </a:gridCol>
              </a:tblGrid>
              <a:tr h="41755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otal sample # 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5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1764036032"/>
                  </a:ext>
                </a:extLst>
              </a:tr>
              <a:tr h="212315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C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R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R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TE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DPK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AKT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AKT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FOXO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FOXO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MTO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RICTO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TSC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TSC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RHEB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AKT1S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RPTO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LST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o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3162403963"/>
                  </a:ext>
                </a:extLst>
              </a:tr>
              <a:tr h="2123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ut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497302758"/>
                  </a:ext>
                </a:extLst>
              </a:tr>
              <a:tr h="41755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mplific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2696857877"/>
                  </a:ext>
                </a:extLst>
              </a:tr>
              <a:tr h="41755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Deep dele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2680830002"/>
                  </a:ext>
                </a:extLst>
              </a:tr>
              <a:tr h="2123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ultipl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3694396947"/>
                  </a:ext>
                </a:extLst>
              </a:tr>
              <a:tr h="2123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o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4137923604"/>
                  </a:ext>
                </a:extLst>
              </a:tr>
              <a:tr h="6227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utative driver to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5</a:t>
                      </a: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4072770212"/>
                  </a:ext>
                </a:extLst>
              </a:tr>
              <a:tr h="21231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44279"/>
                  </a:ext>
                </a:extLst>
              </a:tr>
              <a:tr h="21231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%</a:t>
                      </a: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C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R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R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TE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DPK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KT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KT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FOXO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FOXO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T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ICT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SC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SC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HE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KT1S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PT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LST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otal</a:t>
                      </a: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2582750324"/>
                  </a:ext>
                </a:extLst>
              </a:tr>
              <a:tr h="41755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ut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1.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3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9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.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9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3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3.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3271837187"/>
                  </a:ext>
                </a:extLst>
              </a:tr>
              <a:tr h="41755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mplific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4.4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3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5.4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9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5.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2970332645"/>
                  </a:ext>
                </a:extLst>
              </a:tr>
              <a:tr h="41755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Deep dele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7.0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9.9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763877627"/>
                  </a:ext>
                </a:extLst>
              </a:tr>
              <a:tr h="41755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ultipl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.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6.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3231932309"/>
                  </a:ext>
                </a:extLst>
              </a:tr>
              <a:tr h="41755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o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50.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9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7.0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5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6.6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5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.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2.7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7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9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5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88.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2573625565"/>
                  </a:ext>
                </a:extLst>
              </a:tr>
              <a:tr h="41755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utative driv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0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1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1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9.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6.6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.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2.7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9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04" marR="6304" marT="6304" marB="0" anchor="b"/>
                </a:tc>
                <a:extLst>
                  <a:ext uri="{0D108BD9-81ED-4DB2-BD59-A6C34878D82A}">
                    <a16:rowId xmlns:a16="http://schemas.microsoft.com/office/drawing/2014/main" val="955450049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9DE1DC69-BA7F-95CE-F6D6-0D4FFB81BA1F}"/>
              </a:ext>
            </a:extLst>
          </p:cNvPr>
          <p:cNvSpPr/>
          <p:nvPr/>
        </p:nvSpPr>
        <p:spPr>
          <a:xfrm>
            <a:off x="3598864" y="-139700"/>
            <a:ext cx="3776662" cy="914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ng Squamous Cell Carcinom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9DF0E11-B091-92A0-5779-34117632E27D}"/>
              </a:ext>
            </a:extLst>
          </p:cNvPr>
          <p:cNvSpPr txBox="1"/>
          <p:nvPr/>
        </p:nvSpPr>
        <p:spPr>
          <a:xfrm>
            <a:off x="235390" y="181069"/>
            <a:ext cx="9325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14582395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D5BFFF2-41A0-E816-4045-82594BA2F63B}"/>
              </a:ext>
            </a:extLst>
          </p:cNvPr>
          <p:cNvSpPr txBox="1"/>
          <p:nvPr/>
        </p:nvSpPr>
        <p:spPr>
          <a:xfrm>
            <a:off x="425513" y="244443"/>
            <a:ext cx="11181030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#1. Genomic alterations along the PI3K/AKT/mTOR pathwa</a:t>
            </a:r>
            <a:r>
              <a:rPr lang="en-US" dirty="0"/>
              <a:t>y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 also analyzed 586 lung adenocarcinoma samples to determine the prevalence of alterations in 17 genes of the PI3K/AKT/mTOR pathway. Alterations in this pathway were identified in 42.8% of lung adenocarcinoma cases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and 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most frequently altered genes we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CTO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K3C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O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ccounting for 13.3% (78 samples), 7.6% (45 samples), and 6.3% (37 samples) of cases, respectively. We next analyzed the nature of these genetic alterations (D), found that most were putative driver mutations. For instance, among the 45 cases with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K3C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terations (D), 95% (43 cases) were classified as putative drivers, including 29 activating mutations, 11 gene amplifications, and 3 cases with combined activating mutations and gene amplifications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E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 negative regulator of the PI3K pathway, exhibited 16 alterations (2.73%), including 6 deep deletions and 10 mutations that were known or likely oncogenic (D). Similar patterns were observed in other genes within the PI3K pathway.</a:t>
            </a:r>
          </a:p>
        </p:txBody>
      </p:sp>
    </p:spTree>
    <p:extLst>
      <p:ext uri="{BB962C8B-B14F-4D97-AF65-F5344CB8AC3E}">
        <p14:creationId xmlns:p14="http://schemas.microsoft.com/office/powerpoint/2010/main" val="16208637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8781C10-45E3-B6B7-8B52-1526140B17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72951" y="1318587"/>
            <a:ext cx="4787900" cy="385726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BF18CB60-751D-7FD3-98FD-84E110D9362A}"/>
              </a:ext>
            </a:extLst>
          </p:cNvPr>
          <p:cNvSpPr/>
          <p:nvPr/>
        </p:nvSpPr>
        <p:spPr>
          <a:xfrm>
            <a:off x="3948178" y="496708"/>
            <a:ext cx="3213100" cy="914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ng Adenocarcinom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9A14B0C-72FD-014C-B62D-26BDDA00B045}"/>
              </a:ext>
            </a:extLst>
          </p:cNvPr>
          <p:cNvSpPr txBox="1"/>
          <p:nvPr/>
        </p:nvSpPr>
        <p:spPr>
          <a:xfrm>
            <a:off x="692670" y="5074396"/>
            <a:ext cx="1114373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erations along the PI3K/AKT/mTOR pathway in lung adenocarcinoma were analyzed using genomic data from the TCGA database through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BioPort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www.cbioportal.or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Genomic alterations in 17 genes within the PI3K pathway, along with their combined alterations, are shown.</a:t>
            </a:r>
            <a:endParaRPr lang="en-US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19F1A53-B474-2231-3E57-B57070C1BA1F}"/>
              </a:ext>
            </a:extLst>
          </p:cNvPr>
          <p:cNvSpPr txBox="1"/>
          <p:nvPr/>
        </p:nvSpPr>
        <p:spPr>
          <a:xfrm>
            <a:off x="235390" y="181069"/>
            <a:ext cx="9325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16655138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45FA1BD-CF45-0D99-A615-CAB7175246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7034132"/>
              </p:ext>
            </p:extLst>
          </p:nvPr>
        </p:nvGraphicFramePr>
        <p:xfrm>
          <a:off x="551884" y="1422573"/>
          <a:ext cx="10864533" cy="434484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11103">
                  <a:extLst>
                    <a:ext uri="{9D8B030D-6E8A-4147-A177-3AD203B41FA5}">
                      <a16:colId xmlns:a16="http://schemas.microsoft.com/office/drawing/2014/main" val="3237883429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2119066771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3784212697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2491470758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1408852867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1961376613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416838128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676681764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1366356096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1143516111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231164086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2777197420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953896084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3667646653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2481286028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3549340078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3246080706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2595791554"/>
                    </a:ext>
                  </a:extLst>
                </a:gridCol>
                <a:gridCol w="569635">
                  <a:extLst>
                    <a:ext uri="{9D8B030D-6E8A-4147-A177-3AD203B41FA5}">
                      <a16:colId xmlns:a16="http://schemas.microsoft.com/office/drawing/2014/main" val="320156843"/>
                    </a:ext>
                  </a:extLst>
                </a:gridCol>
              </a:tblGrid>
              <a:tr h="207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otal sample #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384789748"/>
                  </a:ext>
                </a:extLst>
              </a:tr>
              <a:tr h="139844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C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R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R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TE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DPK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KT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KT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FOXO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FOXO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T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ICT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SC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SC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HE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KT1S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PT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LST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o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317000491"/>
                  </a:ext>
                </a:extLst>
              </a:tr>
              <a:tr h="207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ut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4092872477"/>
                  </a:ext>
                </a:extLst>
              </a:tr>
              <a:tr h="207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mplific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717294684"/>
                  </a:ext>
                </a:extLst>
              </a:tr>
              <a:tr h="207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Deep Dele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50675672"/>
                  </a:ext>
                </a:extLst>
              </a:tr>
              <a:tr h="105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ultipl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2882793428"/>
                  </a:ext>
                </a:extLst>
              </a:tr>
              <a:tr h="105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o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409268452"/>
                  </a:ext>
                </a:extLst>
              </a:tr>
              <a:tr h="207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utative  driver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417800637"/>
                  </a:ext>
                </a:extLst>
              </a:tr>
              <a:tr h="105606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00"/>
                        </a:highlight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7547291"/>
                  </a:ext>
                </a:extLst>
              </a:tr>
              <a:tr h="105606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C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R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IK3R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TE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DPK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KT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KT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FOXO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FOXO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T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ICT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SC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SC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HE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KT1S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PT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LST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otal</a:t>
                      </a: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025717687"/>
                  </a:ext>
                </a:extLst>
              </a:tr>
              <a:tr h="207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ut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.9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7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.9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5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8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2.3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203717106"/>
                  </a:ext>
                </a:extLst>
              </a:tr>
              <a:tr h="207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Amplific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8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8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5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6.2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232984136"/>
                  </a:ext>
                </a:extLst>
              </a:tr>
              <a:tr h="207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Deep Dele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.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761846929"/>
                  </a:ext>
                </a:extLst>
              </a:tr>
              <a:tr h="105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ultipl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5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3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8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531991322"/>
                  </a:ext>
                </a:extLst>
              </a:tr>
              <a:tr h="105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To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7.6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7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8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5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7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6.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3.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0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7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5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5.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2.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913113461"/>
                  </a:ext>
                </a:extLst>
              </a:tr>
              <a:tr h="207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utative  driver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9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7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5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5.9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3.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8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5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5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5.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60" marR="6360" marT="6360" marB="0" anchor="b"/>
                </a:tc>
                <a:extLst>
                  <a:ext uri="{0D108BD9-81ED-4DB2-BD59-A6C34878D82A}">
                    <a16:rowId xmlns:a16="http://schemas.microsoft.com/office/drawing/2014/main" val="1064170109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32BFA578-F979-8C86-456B-D3FD7CECFBFF}"/>
              </a:ext>
            </a:extLst>
          </p:cNvPr>
          <p:cNvSpPr/>
          <p:nvPr/>
        </p:nvSpPr>
        <p:spPr>
          <a:xfrm>
            <a:off x="4402308" y="579421"/>
            <a:ext cx="3213100" cy="9144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ng Adenocarcinom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5FF5466-A0FA-73C7-F0D3-66E6CA3A2CBB}"/>
              </a:ext>
            </a:extLst>
          </p:cNvPr>
          <p:cNvSpPr txBox="1"/>
          <p:nvPr/>
        </p:nvSpPr>
        <p:spPr>
          <a:xfrm>
            <a:off x="235390" y="181069"/>
            <a:ext cx="9325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558723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013</Words>
  <Application>Microsoft Office PowerPoint</Application>
  <PresentationFormat>Widescreen</PresentationFormat>
  <Paragraphs>50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ptos Narrow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Chong-Xian</dc:creator>
  <cp:lastModifiedBy>Pan, Chong-Xian</cp:lastModifiedBy>
  <cp:revision>3</cp:revision>
  <dcterms:created xsi:type="dcterms:W3CDTF">2024-12-19T15:08:57Z</dcterms:created>
  <dcterms:modified xsi:type="dcterms:W3CDTF">2024-12-30T20:31:45Z</dcterms:modified>
</cp:coreProperties>
</file>